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2"/>
  </p:sldMasterIdLst>
  <p:sldIdLst>
    <p:sldId id="257" r:id="rId3"/>
  </p:sldIdLst>
  <p:sldSz cx="12192000" cy="6858000"/>
  <p:notesSz cx="6858000" cy="9144000"/>
  <p:custDataLst>
    <p:custData r:id="rId1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er Ashorn (TAU)" initials="PA(" lastIdx="2" clrIdx="0">
    <p:extLst>
      <p:ext uri="{19B8F6BF-5375-455C-9EA6-DF929625EA0E}">
        <p15:presenceInfo xmlns:p15="http://schemas.microsoft.com/office/powerpoint/2012/main" userId="S::per.ashorn@tuni.fi::2dd6b6ad-fe7d-4eab-96b9-4ecd7717a1bc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4" d="100"/>
          <a:sy n="84" d="100"/>
        </p:scale>
        <p:origin x="581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62950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460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6286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3845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1264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13753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1025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17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8680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032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266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3A3291-19CC-4977-AE69-486F01E25634}" type="datetimeFigureOut">
              <a:rPr lang="en-US" smtClean="0"/>
              <a:t>12/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29FD91-1825-4A17-9507-B1B7A2132E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27424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34"/>
          <p:cNvSpPr txBox="1">
            <a:spLocks noChangeArrowheads="1"/>
          </p:cNvSpPr>
          <p:nvPr/>
        </p:nvSpPr>
        <p:spPr bwMode="auto">
          <a:xfrm>
            <a:off x="2664030" y="2439925"/>
            <a:ext cx="1012766" cy="46826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FA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105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2132526" y="868680"/>
            <a:ext cx="8329393" cy="5492398"/>
            <a:chOff x="2132526" y="868680"/>
            <a:chExt cx="8329393" cy="5492398"/>
          </a:xfrm>
        </p:grpSpPr>
        <p:sp>
          <p:nvSpPr>
            <p:cNvPr id="9" name="TextBox 33"/>
            <p:cNvSpPr txBox="1">
              <a:spLocks noChangeArrowheads="1"/>
            </p:cNvSpPr>
            <p:nvPr/>
          </p:nvSpPr>
          <p:spPr bwMode="auto">
            <a:xfrm>
              <a:off x="8657889" y="2414807"/>
              <a:ext cx="1085686" cy="495752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Q-</a:t>
              </a: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LNS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107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35"/>
            <p:cNvSpPr txBox="1">
              <a:spLocks noChangeArrowheads="1"/>
            </p:cNvSpPr>
            <p:nvPr/>
          </p:nvSpPr>
          <p:spPr bwMode="auto">
            <a:xfrm>
              <a:off x="5571609" y="2413335"/>
              <a:ext cx="1077248" cy="512907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</a:t>
              </a: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MN</a:t>
              </a: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106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31"/>
            <p:cNvSpPr txBox="1"/>
            <p:nvPr/>
          </p:nvSpPr>
          <p:spPr>
            <a:xfrm>
              <a:off x="2132526" y="3189367"/>
              <a:ext cx="2310810" cy="63672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u="sng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36 </a:t>
              </a:r>
              <a:r>
                <a:rPr lang="en-US" sz="1200" u="sng" dirty="0" err="1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wk</a:t>
              </a:r>
              <a:r>
                <a:rPr lang="en-US" sz="1200" u="sng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gestation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:</a:t>
              </a: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aternal plasma retinol: n=103</a:t>
              </a: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42" name="Text Box 26"/>
            <p:cNvSpPr txBox="1">
              <a:spLocks noChangeArrowheads="1"/>
            </p:cNvSpPr>
            <p:nvPr/>
          </p:nvSpPr>
          <p:spPr bwMode="auto">
            <a:xfrm>
              <a:off x="2132526" y="4060143"/>
              <a:ext cx="2310810" cy="1395674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sng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6 </a:t>
              </a:r>
              <a:r>
                <a:rPr kumimoji="0" lang="en-US" altLang="en-US" sz="1200" b="0" i="0" u="sng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o</a:t>
              </a:r>
              <a:r>
                <a:rPr kumimoji="0" lang="en-US" altLang="en-US" sz="1200" b="0" i="0" u="sng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postpartum</a:t>
              </a: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: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ternal plasma retinol: n=103 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ternal </a:t>
              </a: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lk retinol: n=103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sng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Child </a:t>
              </a:r>
              <a:r>
                <a:rPr kumimoji="0" lang="en-US" altLang="en-US" sz="1200" b="0" i="0" u="sng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kumimoji="0" lang="en-US" altLang="en-US" sz="1200" b="0" i="0" u="sng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0" lang="en-US" altLang="en-US" sz="1200" b="0" i="0" u="sng" strike="noStrike" cap="none" normalizeH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mo</a:t>
              </a:r>
              <a:r>
                <a:rPr kumimoji="0" lang="en-US" altLang="en-US" sz="1200" b="0" i="0" u="sng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of age</a:t>
              </a:r>
              <a:r>
                <a:rPr kumimoji="0" lang="en-US" altLang="en-US" sz="1200" b="0" i="0" u="none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Child</a:t>
              </a:r>
              <a:r>
                <a:rPr kumimoji="0" lang="en-US" altLang="en-US" sz="1200" b="0" i="0" u="none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plasma </a:t>
              </a: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tinol</a:t>
              </a:r>
              <a:r>
                <a:rPr kumimoji="0" lang="en-US" altLang="en-US" sz="1200" b="0" i="0" u="none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: n=86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kumimoji="0" lang="en-US" altLang="en-US" sz="1000" b="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baseline="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kumimoji="0" lang="en-US" altLang="en-US" sz="9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TextBox 6"/>
            <p:cNvSpPr txBox="1">
              <a:spLocks noChangeArrowheads="1"/>
            </p:cNvSpPr>
            <p:nvPr/>
          </p:nvSpPr>
          <p:spPr bwMode="auto">
            <a:xfrm>
              <a:off x="4905264" y="868680"/>
              <a:ext cx="2443960" cy="368798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lang="en-US" altLang="en-US" sz="9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1,391</a:t>
              </a: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mother-chil</a:t>
              </a: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d pairs</a:t>
              </a: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enrolled</a:t>
              </a: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31"/>
            <p:cNvSpPr txBox="1"/>
            <p:nvPr/>
          </p:nvSpPr>
          <p:spPr>
            <a:xfrm>
              <a:off x="8177203" y="3186931"/>
              <a:ext cx="2284716" cy="63658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u="sng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36 </a:t>
              </a:r>
              <a:r>
                <a:rPr lang="en-US" sz="1200" u="sng" dirty="0" err="1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wk</a:t>
              </a:r>
              <a:r>
                <a:rPr lang="en-US" sz="1200" u="sng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gestation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:</a:t>
              </a: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aternal plasma retinol n=105</a:t>
              </a: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endParaRPr lang="en-US" sz="1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122" name="TextBox 31"/>
            <p:cNvSpPr txBox="1"/>
            <p:nvPr/>
          </p:nvSpPr>
          <p:spPr>
            <a:xfrm>
              <a:off x="5087985" y="3186931"/>
              <a:ext cx="2280742" cy="6412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u="sng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36 </a:t>
              </a:r>
              <a:r>
                <a:rPr lang="en-US" sz="1200" u="sng" dirty="0" err="1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wk</a:t>
              </a:r>
              <a:r>
                <a:rPr lang="en-US" sz="1200" u="sng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gestation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:</a:t>
              </a: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aternal plasma retinol n=105</a:t>
              </a: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0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</a:t>
              </a:r>
            </a:p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endParaRPr lang="en-US" sz="9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Text Box 26"/>
            <p:cNvSpPr txBox="1">
              <a:spLocks noChangeArrowheads="1"/>
            </p:cNvSpPr>
            <p:nvPr/>
          </p:nvSpPr>
          <p:spPr bwMode="auto">
            <a:xfrm>
              <a:off x="8177203" y="4096902"/>
              <a:ext cx="2284716" cy="1407845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00" u="sng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6 </a:t>
              </a:r>
              <a:r>
                <a:rPr lang="en-US" altLang="en-US" sz="1200" u="sng" dirty="0" err="1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o</a:t>
              </a:r>
              <a:r>
                <a:rPr lang="en-US" altLang="en-US" sz="1200" u="sng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postpartum:</a:t>
              </a:r>
              <a:endParaRPr lang="en-US" alt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ternal plasma retinol: n=107</a:t>
              </a:r>
            </a:p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ternal </a:t>
              </a: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lk retinol: </a:t>
              </a:r>
              <a:r>
                <a:rPr lang="en-US" alt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=106</a:t>
              </a:r>
              <a:endParaRPr lang="en-US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00" u="sng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ild </a:t>
              </a:r>
              <a:r>
                <a:rPr lang="en-US" altLang="en-US" sz="1200" u="sng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 </a:t>
              </a:r>
              <a:r>
                <a:rPr lang="en-US" altLang="en-US" sz="1200" u="sng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o</a:t>
              </a:r>
              <a:r>
                <a:rPr lang="en-US" altLang="en-US" sz="1200" u="sng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of age</a:t>
              </a: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</a:p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ild plasma retinol: n=78</a:t>
              </a:r>
            </a:p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 Box 26"/>
            <p:cNvSpPr txBox="1">
              <a:spLocks noChangeArrowheads="1"/>
            </p:cNvSpPr>
            <p:nvPr/>
          </p:nvSpPr>
          <p:spPr bwMode="auto">
            <a:xfrm>
              <a:off x="5087985" y="4066055"/>
              <a:ext cx="2274923" cy="1395672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00" u="sng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6 </a:t>
              </a:r>
              <a:r>
                <a:rPr lang="en-US" altLang="en-US" sz="1200" u="sng" dirty="0" err="1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o</a:t>
              </a:r>
              <a:r>
                <a:rPr lang="en-US" altLang="en-US" sz="1200" u="sng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postpartum</a:t>
              </a: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:</a:t>
              </a:r>
            </a:p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ternal plasma retinol: n=106 </a:t>
              </a:r>
            </a:p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00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ternal </a:t>
              </a: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lk retinol: n=106</a:t>
              </a:r>
            </a:p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alt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00" u="sng" dirty="0" smtClean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ild </a:t>
              </a:r>
              <a:r>
                <a:rPr lang="en-US" altLang="en-US" sz="1200" u="sng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 </a:t>
              </a:r>
              <a:r>
                <a:rPr lang="en-US" altLang="en-US" sz="1200" u="sng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o</a:t>
              </a:r>
              <a:r>
                <a:rPr lang="en-US" altLang="en-US" sz="1200" u="sng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of age</a:t>
              </a: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</a:p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ild plasma retinol: n=90</a:t>
              </a:r>
            </a:p>
            <a:p>
              <a:pPr lvl="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Text Box 26"/>
            <p:cNvSpPr txBox="1">
              <a:spLocks noChangeArrowheads="1"/>
            </p:cNvSpPr>
            <p:nvPr/>
          </p:nvSpPr>
          <p:spPr bwMode="auto">
            <a:xfrm>
              <a:off x="2132528" y="5746391"/>
              <a:ext cx="2310809" cy="605882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200" u="sng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Child 18 </a:t>
              </a:r>
              <a:r>
                <a:rPr lang="en-US" altLang="en-US" sz="1200" u="sng" dirty="0" err="1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o</a:t>
              </a:r>
              <a:r>
                <a:rPr lang="en-US" altLang="en-US" sz="1200" u="sng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of age</a:t>
              </a: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: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Child plasma retinol: n=85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1" name="Text Box 26"/>
            <p:cNvSpPr txBox="1">
              <a:spLocks noChangeArrowheads="1"/>
            </p:cNvSpPr>
            <p:nvPr/>
          </p:nvSpPr>
          <p:spPr bwMode="auto">
            <a:xfrm>
              <a:off x="8177203" y="5746977"/>
              <a:ext cx="2284716" cy="614101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200" u="sng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Child 18 </a:t>
              </a:r>
              <a:r>
                <a:rPr lang="en-US" altLang="en-US" sz="1200" u="sng" dirty="0" err="1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o</a:t>
              </a:r>
              <a:r>
                <a:rPr lang="en-US" altLang="en-US" sz="1200" u="sng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of age</a:t>
              </a:r>
              <a:r>
                <a:rPr kumimoji="0" lang="en-US" altLang="en-US" sz="1200" b="0" i="0" u="sng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: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Child plasma retinol: n=78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42" name="Text Box 26"/>
            <p:cNvSpPr txBox="1">
              <a:spLocks noChangeArrowheads="1"/>
            </p:cNvSpPr>
            <p:nvPr/>
          </p:nvSpPr>
          <p:spPr bwMode="auto">
            <a:xfrm>
              <a:off x="5087985" y="5746977"/>
              <a:ext cx="2274923" cy="607463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1200" u="sng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Child 18 </a:t>
              </a:r>
              <a:r>
                <a:rPr lang="en-US" altLang="en-US" sz="1200" u="sng" dirty="0" err="1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o</a:t>
              </a:r>
              <a:r>
                <a:rPr lang="en-US" altLang="en-US" sz="1200" u="sng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of age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Child plasma </a:t>
              </a:r>
              <a:r>
                <a:rPr lang="en-US" alt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retinol</a:t>
              </a:r>
              <a:r>
                <a: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: n=90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56" name="Rectangle 55"/>
            <p:cNvSpPr/>
            <p:nvPr/>
          </p:nvSpPr>
          <p:spPr>
            <a:xfrm>
              <a:off x="4837192" y="1482424"/>
              <a:ext cx="2582658" cy="461666"/>
            </a:xfrm>
            <a:prstGeom prst="rect">
              <a:avLst/>
            </a:prstGeom>
            <a:ln>
              <a:noFill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318 mother-child pairs selected for plasma and milk retinol subsample</a:t>
              </a:r>
              <a:endPara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08" name="Straight Arrow Connector 107"/>
          <p:cNvCxnSpPr/>
          <p:nvPr/>
        </p:nvCxnSpPr>
        <p:spPr>
          <a:xfrm flipH="1">
            <a:off x="3170413" y="2950934"/>
            <a:ext cx="2842" cy="17484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5"/>
          <p:cNvSpPr txBox="1">
            <a:spLocks noChangeArrowheads="1"/>
          </p:cNvSpPr>
          <p:nvPr/>
        </p:nvSpPr>
        <p:spPr bwMode="auto">
          <a:xfrm>
            <a:off x="4905264" y="1453957"/>
            <a:ext cx="2443960" cy="484062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9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Straight Arrow Connector 37"/>
          <p:cNvCxnSpPr/>
          <p:nvPr/>
        </p:nvCxnSpPr>
        <p:spPr>
          <a:xfrm flipH="1">
            <a:off x="6128020" y="1989839"/>
            <a:ext cx="2419" cy="192978"/>
          </a:xfrm>
          <a:prstGeom prst="straightConnector1">
            <a:avLst/>
          </a:prstGeom>
          <a:ln w="158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/>
          <p:nvPr/>
        </p:nvCxnSpPr>
        <p:spPr>
          <a:xfrm>
            <a:off x="6124402" y="1271918"/>
            <a:ext cx="1" cy="155041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/>
          <p:cNvCxnSpPr/>
          <p:nvPr/>
        </p:nvCxnSpPr>
        <p:spPr>
          <a:xfrm flipV="1">
            <a:off x="3134474" y="2223269"/>
            <a:ext cx="6146555" cy="8027"/>
          </a:xfrm>
          <a:prstGeom prst="line">
            <a:avLst/>
          </a:prstGeom>
          <a:ln w="158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>
            <a:off x="3134474" y="2231296"/>
            <a:ext cx="0" cy="15936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/>
          <p:nvPr/>
        </p:nvCxnSpPr>
        <p:spPr>
          <a:xfrm>
            <a:off x="6124402" y="2231296"/>
            <a:ext cx="0" cy="15936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/>
          <p:nvPr/>
        </p:nvCxnSpPr>
        <p:spPr>
          <a:xfrm>
            <a:off x="9281029" y="2231296"/>
            <a:ext cx="0" cy="159369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1787729" y="6447170"/>
            <a:ext cx="94660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1. Enrollment and selection of Malawian mother-child pairs for plasma and milk retinol analyses.</a:t>
            </a:r>
          </a:p>
        </p:txBody>
      </p:sp>
      <p:cxnSp>
        <p:nvCxnSpPr>
          <p:cNvPr id="41" name="Straight Arrow Connector 40"/>
          <p:cNvCxnSpPr/>
          <p:nvPr/>
        </p:nvCxnSpPr>
        <p:spPr>
          <a:xfrm flipH="1">
            <a:off x="6122981" y="2972772"/>
            <a:ext cx="2842" cy="17484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/>
          <p:nvPr/>
        </p:nvCxnSpPr>
        <p:spPr>
          <a:xfrm flipH="1">
            <a:off x="9290500" y="2966068"/>
            <a:ext cx="2842" cy="17484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/>
          <p:cNvCxnSpPr/>
          <p:nvPr/>
        </p:nvCxnSpPr>
        <p:spPr>
          <a:xfrm flipH="1">
            <a:off x="9320085" y="3877972"/>
            <a:ext cx="2842" cy="17484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 flipH="1">
            <a:off x="9316719" y="5531868"/>
            <a:ext cx="2842" cy="17484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 flipH="1">
            <a:off x="6124402" y="5523035"/>
            <a:ext cx="2842" cy="17484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/>
          <p:nvPr/>
        </p:nvCxnSpPr>
        <p:spPr>
          <a:xfrm flipH="1">
            <a:off x="6140928" y="3877973"/>
            <a:ext cx="2842" cy="17484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/>
          <p:nvPr/>
        </p:nvCxnSpPr>
        <p:spPr>
          <a:xfrm flipH="1">
            <a:off x="3134474" y="3865279"/>
            <a:ext cx="2842" cy="17484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/>
          <p:nvPr/>
        </p:nvCxnSpPr>
        <p:spPr>
          <a:xfrm flipH="1">
            <a:off x="3134474" y="5513223"/>
            <a:ext cx="2842" cy="17484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116368" y="208405"/>
            <a:ext cx="109268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mall-quantity lipid-based nutrient supplements do not affect plasma or milk retinol concentrations among Malawian mothers, or plasma retinol concentrations </a:t>
            </a:r>
            <a:endParaRPr lang="en-US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mong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young Malawian or Ghanaian children in two randomize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rials, Marjorie Haskell, Online Supplementary Materi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29272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IAPPresMetadata>
  <IAPAddInVersion>5.1.2</IAPAddInVersion>
  <DolphinEchoVersion>6.1.3</DolphinEchoVersion>
</IAPPresMetadata>
</file>

<file path=customXml/itemProps1.xml><?xml version="1.0" encoding="utf-8"?>
<ds:datastoreItem xmlns:ds="http://schemas.openxmlformats.org/officeDocument/2006/customXml" ds:itemID="{D9D2B03F-0740-46D4-82F8-3B8A3387DADB}">
  <ds:schemaRefs/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</TotalTime>
  <Words>216</Words>
  <Application>Microsoft Office PowerPoint</Application>
  <PresentationFormat>Widescreen</PresentationFormat>
  <Paragraphs>4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jorie Haskell</dc:creator>
  <cp:lastModifiedBy>Marjorie Haskell</cp:lastModifiedBy>
  <cp:revision>29</cp:revision>
  <dcterms:modified xsi:type="dcterms:W3CDTF">2020-12-08T20:39:23Z</dcterms:modified>
</cp:coreProperties>
</file>